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6" d="100"/>
          <a:sy n="66" d="100"/>
        </p:scale>
        <p:origin x="341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D126-E420-4A05-9064-AAD83A5ADBDA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C2D24-8AC0-4F48-BF0E-EC1B0ED99D2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120034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D126-E420-4A05-9064-AAD83A5ADBDA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C2D24-8AC0-4F48-BF0E-EC1B0ED99D2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9008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D126-E420-4A05-9064-AAD83A5ADBDA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C2D24-8AC0-4F48-BF0E-EC1B0ED99D2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049265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D126-E420-4A05-9064-AAD83A5ADBDA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C2D24-8AC0-4F48-BF0E-EC1B0ED99D2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363511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D126-E420-4A05-9064-AAD83A5ADBDA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C2D24-8AC0-4F48-BF0E-EC1B0ED99D2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82791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D126-E420-4A05-9064-AAD83A5ADBDA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C2D24-8AC0-4F48-BF0E-EC1B0ED99D2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640286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D126-E420-4A05-9064-AAD83A5ADBDA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C2D24-8AC0-4F48-BF0E-EC1B0ED99D2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094639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D126-E420-4A05-9064-AAD83A5ADBDA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C2D24-8AC0-4F48-BF0E-EC1B0ED99D2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730585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D126-E420-4A05-9064-AAD83A5ADBDA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C2D24-8AC0-4F48-BF0E-EC1B0ED99D2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78866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D126-E420-4A05-9064-AAD83A5ADBDA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C2D24-8AC0-4F48-BF0E-EC1B0ED99D2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001806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D126-E420-4A05-9064-AAD83A5ADBDA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C2D24-8AC0-4F48-BF0E-EC1B0ED99D2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3473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0ED126-E420-4A05-9064-AAD83A5ADBDA}" type="datetimeFigureOut">
              <a:rPr lang="it-IT" smtClean="0"/>
              <a:t>05/03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0C2D24-8AC0-4F48-BF0E-EC1B0ED99D2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121525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ttangolo 8">
            <a:extLst>
              <a:ext uri="{FF2B5EF4-FFF2-40B4-BE49-F238E27FC236}">
                <a16:creationId xmlns:a16="http://schemas.microsoft.com/office/drawing/2014/main" id="{75CDC65E-4537-4651-A7A9-BADF07046E91}"/>
              </a:ext>
            </a:extLst>
          </p:cNvPr>
          <p:cNvSpPr/>
          <p:nvPr/>
        </p:nvSpPr>
        <p:spPr>
          <a:xfrm>
            <a:off x="6309839" y="311877"/>
            <a:ext cx="385763" cy="116111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grpSp>
        <p:nvGrpSpPr>
          <p:cNvPr id="2" name="Gruppo 1">
            <a:extLst>
              <a:ext uri="{FF2B5EF4-FFF2-40B4-BE49-F238E27FC236}">
                <a16:creationId xmlns:a16="http://schemas.microsoft.com/office/drawing/2014/main" id="{71688114-CFE1-47CF-9968-A8911CEF1325}"/>
              </a:ext>
            </a:extLst>
          </p:cNvPr>
          <p:cNvGrpSpPr/>
          <p:nvPr/>
        </p:nvGrpSpPr>
        <p:grpSpPr>
          <a:xfrm>
            <a:off x="219014" y="182720"/>
            <a:ext cx="6043432" cy="10993901"/>
            <a:chOff x="219014" y="182720"/>
            <a:chExt cx="6043432" cy="10993901"/>
          </a:xfrm>
        </p:grpSpPr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F3E7708E-8C98-4920-9D33-AC0477DA1B6F}"/>
                </a:ext>
              </a:extLst>
            </p:cNvPr>
            <p:cNvSpPr txBox="1"/>
            <p:nvPr/>
          </p:nvSpPr>
          <p:spPr>
            <a:xfrm>
              <a:off x="219014" y="182720"/>
              <a:ext cx="57903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>
                  <a:latin typeface="Palatino Linotype" panose="02040502050505030304" pitchFamily="18" charset="0"/>
                </a:rPr>
                <a:t>Figure S1. </a:t>
              </a:r>
              <a:r>
                <a:rPr lang="en-US" sz="900" dirty="0" err="1">
                  <a:latin typeface="Palatino Linotype" panose="02040502050505030304" pitchFamily="18" charset="0"/>
                </a:rPr>
                <a:t>Dendogram</a:t>
              </a:r>
              <a:r>
                <a:rPr lang="en-US" sz="900" dirty="0">
                  <a:latin typeface="Palatino Linotype" panose="02040502050505030304" pitchFamily="18" charset="0"/>
                </a:rPr>
                <a:t> of the Central-Western Mediterranean accessions based on the UPGMA methodology </a:t>
              </a:r>
            </a:p>
            <a:p>
              <a:r>
                <a:rPr lang="en-US" sz="900" dirty="0">
                  <a:latin typeface="Palatino Linotype" panose="02040502050505030304" pitchFamily="18" charset="0"/>
                </a:rPr>
                <a:t>according to the Dice coefficient. </a:t>
              </a:r>
              <a:r>
                <a:rPr lang="it-IT" sz="900" b="1" dirty="0">
                  <a:latin typeface="Palatino Linotype" panose="02040502050505030304" pitchFamily="18" charset="0"/>
                </a:rPr>
                <a:t> </a:t>
              </a:r>
            </a:p>
          </p:txBody>
        </p:sp>
        <p:pic>
          <p:nvPicPr>
            <p:cNvPr id="16" name="Immagine 15">
              <a:extLst>
                <a:ext uri="{FF2B5EF4-FFF2-40B4-BE49-F238E27FC236}">
                  <a16:creationId xmlns:a16="http://schemas.microsoft.com/office/drawing/2014/main" id="{C627D1FA-1E24-40BE-A7FD-EFA68148CC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2076" b="8074"/>
            <a:stretch/>
          </p:blipFill>
          <p:spPr>
            <a:xfrm rot="5400000">
              <a:off x="1277899" y="418216"/>
              <a:ext cx="4746164" cy="5222928"/>
            </a:xfrm>
            <a:prstGeom prst="rect">
              <a:avLst/>
            </a:prstGeom>
          </p:spPr>
        </p:pic>
        <p:pic>
          <p:nvPicPr>
            <p:cNvPr id="17" name="Immagine 16">
              <a:extLst>
                <a:ext uri="{FF2B5EF4-FFF2-40B4-BE49-F238E27FC236}">
                  <a16:creationId xmlns:a16="http://schemas.microsoft.com/office/drawing/2014/main" id="{BC10A790-AFED-41AF-9D67-D777FFE4661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09" t="2076" b="8074"/>
            <a:stretch/>
          </p:blipFill>
          <p:spPr>
            <a:xfrm rot="5400000">
              <a:off x="1285228" y="4674455"/>
              <a:ext cx="4731500" cy="5222934"/>
            </a:xfrm>
            <a:prstGeom prst="rect">
              <a:avLst/>
            </a:prstGeom>
          </p:spPr>
        </p:pic>
        <p:pic>
          <p:nvPicPr>
            <p:cNvPr id="18" name="Immagine 17">
              <a:extLst>
                <a:ext uri="{FF2B5EF4-FFF2-40B4-BE49-F238E27FC236}">
                  <a16:creationId xmlns:a16="http://schemas.microsoft.com/office/drawing/2014/main" id="{64A0F1C5-A6CF-40EB-9B86-85B62A7EA1B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09" t="2076" r="8914" b="8074"/>
            <a:stretch/>
          </p:blipFill>
          <p:spPr>
            <a:xfrm rot="5400000">
              <a:off x="1496765" y="6410940"/>
              <a:ext cx="4308422" cy="522294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7398204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83CC9E2C073C3F4C812A5E526F3FEA55" ma:contentTypeVersion="13" ma:contentTypeDescription="Creare un nuovo documento." ma:contentTypeScope="" ma:versionID="4d3d2d9c3db70910840ef4b840f62744">
  <xsd:schema xmlns:xsd="http://www.w3.org/2001/XMLSchema" xmlns:xs="http://www.w3.org/2001/XMLSchema" xmlns:p="http://schemas.microsoft.com/office/2006/metadata/properties" xmlns:ns3="c89df9c4-d520-4044-b0b2-96c16863b82d" xmlns:ns4="db74c5cb-3b3f-41fe-b4e9-5cdfcfe4d908" targetNamespace="http://schemas.microsoft.com/office/2006/metadata/properties" ma:root="true" ma:fieldsID="f7864d51d2f44e37ac66506d5767410d" ns3:_="" ns4:_="">
    <xsd:import namespace="c89df9c4-d520-4044-b0b2-96c16863b82d"/>
    <xsd:import namespace="db74c5cb-3b3f-41fe-b4e9-5cdfcfe4d908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89df9c4-d520-4044-b0b2-96c16863b82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Location" ma:internalName="MediaServiceLocation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b74c5cb-3b3f-41fe-b4e9-5cdfcfe4d908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Condivis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Condiviso con dettagli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Hash suggerimento condivisione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i contenuto"/>
        <xsd:element ref="dc:title" minOccurs="0" maxOccurs="1" ma:index="4" ma:displayName="Tito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1A9B358D-F3ED-454F-AE05-DEA26ABEC5F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89df9c4-d520-4044-b0b2-96c16863b82d"/>
    <ds:schemaRef ds:uri="db74c5cb-3b3f-41fe-b4e9-5cdfcfe4d90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F0256E5F-74F7-43E7-B99B-3D482BEDF41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9E49E63A-5657-4554-A365-348B4BC758D7}">
  <ds:schemaRefs>
    <ds:schemaRef ds:uri="http://schemas.microsoft.com/office/2006/metadata/properties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4</TotalTime>
  <Words>20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manta zelasco</dc:creator>
  <cp:lastModifiedBy>samanta zelasco</cp:lastModifiedBy>
  <cp:revision>18</cp:revision>
  <dcterms:created xsi:type="dcterms:W3CDTF">2020-12-29T10:14:03Z</dcterms:created>
  <dcterms:modified xsi:type="dcterms:W3CDTF">2021-03-05T18:38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3CC9E2C073C3F4C812A5E526F3FEA55</vt:lpwstr>
  </property>
</Properties>
</file>